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1" d="100"/>
          <a:sy n="111" d="100"/>
        </p:scale>
        <p:origin x="-516" y="-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22EC-40BC-45FD-AA55-FDC54075065B}" type="datetimeFigureOut">
              <a:rPr lang="zh-CN" altLang="en-US" smtClean="0"/>
              <a:t>2018-7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84E33-707C-475A-88C0-4855BA7EB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06276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22EC-40BC-45FD-AA55-FDC54075065B}" type="datetimeFigureOut">
              <a:rPr lang="zh-CN" altLang="en-US" smtClean="0"/>
              <a:t>2018-7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84E33-707C-475A-88C0-4855BA7EB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0527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22EC-40BC-45FD-AA55-FDC54075065B}" type="datetimeFigureOut">
              <a:rPr lang="zh-CN" altLang="en-US" smtClean="0"/>
              <a:t>2018-7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84E33-707C-475A-88C0-4855BA7EB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0360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22EC-40BC-45FD-AA55-FDC54075065B}" type="datetimeFigureOut">
              <a:rPr lang="zh-CN" altLang="en-US" smtClean="0"/>
              <a:t>2018-7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84E33-707C-475A-88C0-4855BA7EB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1431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22EC-40BC-45FD-AA55-FDC54075065B}" type="datetimeFigureOut">
              <a:rPr lang="zh-CN" altLang="en-US" smtClean="0"/>
              <a:t>2018-7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84E33-707C-475A-88C0-4855BA7EB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9258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22EC-40BC-45FD-AA55-FDC54075065B}" type="datetimeFigureOut">
              <a:rPr lang="zh-CN" altLang="en-US" smtClean="0"/>
              <a:t>2018-7-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84E33-707C-475A-88C0-4855BA7EB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1647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22EC-40BC-45FD-AA55-FDC54075065B}" type="datetimeFigureOut">
              <a:rPr lang="zh-CN" altLang="en-US" smtClean="0"/>
              <a:t>2018-7-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84E33-707C-475A-88C0-4855BA7EB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4629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22EC-40BC-45FD-AA55-FDC54075065B}" type="datetimeFigureOut">
              <a:rPr lang="zh-CN" altLang="en-US" smtClean="0"/>
              <a:t>2018-7-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84E33-707C-475A-88C0-4855BA7EB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8598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22EC-40BC-45FD-AA55-FDC54075065B}" type="datetimeFigureOut">
              <a:rPr lang="zh-CN" altLang="en-US" smtClean="0"/>
              <a:t>2018-7-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84E33-707C-475A-88C0-4855BA7EB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9546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22EC-40BC-45FD-AA55-FDC54075065B}" type="datetimeFigureOut">
              <a:rPr lang="zh-CN" altLang="en-US" smtClean="0"/>
              <a:t>2018-7-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84E33-707C-475A-88C0-4855BA7EB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4094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922EC-40BC-45FD-AA55-FDC54075065B}" type="datetimeFigureOut">
              <a:rPr lang="zh-CN" altLang="en-US" smtClean="0"/>
              <a:t>2018-7-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84E33-707C-475A-88C0-4855BA7EB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35553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7922EC-40BC-45FD-AA55-FDC54075065B}" type="datetimeFigureOut">
              <a:rPr lang="zh-CN" altLang="en-US" smtClean="0"/>
              <a:t>2018-7-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A84E33-707C-475A-88C0-4855BA7EB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7137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图片 2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7408" y="769134"/>
            <a:ext cx="7084166" cy="1950889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28268" y="2811354"/>
            <a:ext cx="3650103" cy="2666286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20618" y="2906831"/>
            <a:ext cx="3592791" cy="2647812"/>
          </a:xfrm>
          <a:prstGeom prst="rect">
            <a:avLst/>
          </a:prstGeom>
        </p:spPr>
      </p:pic>
      <p:sp>
        <p:nvSpPr>
          <p:cNvPr id="29" name="文本框 28"/>
          <p:cNvSpPr txBox="1"/>
          <p:nvPr/>
        </p:nvSpPr>
        <p:spPr>
          <a:xfrm>
            <a:off x="1944303" y="543263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a</a:t>
            </a:r>
            <a:endParaRPr lang="zh-CN" altLang="en-US" dirty="0"/>
          </a:p>
        </p:txBody>
      </p:sp>
      <p:sp>
        <p:nvSpPr>
          <p:cNvPr id="30" name="文本框 29"/>
          <p:cNvSpPr txBox="1"/>
          <p:nvPr/>
        </p:nvSpPr>
        <p:spPr>
          <a:xfrm>
            <a:off x="1956049" y="259434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31" name="文本框 30"/>
          <p:cNvSpPr txBox="1"/>
          <p:nvPr/>
        </p:nvSpPr>
        <p:spPr>
          <a:xfrm>
            <a:off x="5810000" y="2594347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c</a:t>
            </a:r>
            <a:endParaRPr lang="zh-CN" altLang="en-US" dirty="0"/>
          </a:p>
        </p:txBody>
      </p:sp>
      <p:sp>
        <p:nvSpPr>
          <p:cNvPr id="32" name="矩形 31"/>
          <p:cNvSpPr/>
          <p:nvPr/>
        </p:nvSpPr>
        <p:spPr>
          <a:xfrm>
            <a:off x="131546" y="112376"/>
            <a:ext cx="11909658" cy="430887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200" b="1" dirty="0" smtClean="0"/>
              <a:t>Figure S1. </a:t>
            </a:r>
            <a:r>
              <a:rPr lang="en-US" altLang="zh-CN" sz="2200" b="1" dirty="0"/>
              <a:t>CQ </a:t>
            </a:r>
            <a:r>
              <a:rPr lang="en-US" altLang="zh-CN" sz="2200" b="1" dirty="0" smtClean="0"/>
              <a:t> increase aβ levels </a:t>
            </a:r>
            <a:endParaRPr lang="zh-CN" altLang="en-US" sz="2200" b="1" dirty="0"/>
          </a:p>
        </p:txBody>
      </p:sp>
      <p:sp>
        <p:nvSpPr>
          <p:cNvPr id="3" name="矩形 2"/>
          <p:cNvSpPr/>
          <p:nvPr/>
        </p:nvSpPr>
        <p:spPr>
          <a:xfrm>
            <a:off x="267903" y="5650120"/>
            <a:ext cx="1163694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APP/PS1 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mice were continuously exposed to 3% sevoflurane or 60% oxygen for 4 h (n=5/group). For 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CQ 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treatment, mice were intraperitoneally pre-injected with 15 mg/kg/day 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CQ 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followed 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by 4 hours of 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sevoflurane or oxygen exposure. (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a) Western blotting results of the APP, α-CTF,  β-CTF and β-actin of the mouse 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hippocampus. 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(b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),(c) 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Quantification of the ratio of APP and β-CTF to β-actin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. ***p&lt;0.001.</a:t>
            </a:r>
            <a:endParaRPr lang="zh-CN" altLang="en-US" kern="100" dirty="0">
              <a:latin typeface="Times New Roman" panose="02020603050405020304" pitchFamily="18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17831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2671" y="3332669"/>
            <a:ext cx="3376126" cy="2334927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38797" y="3338094"/>
            <a:ext cx="3016961" cy="2329502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2894080" y="322094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b</a:t>
            </a:r>
            <a:endParaRPr lang="zh-CN" altLang="en-US" dirty="0"/>
          </a:p>
        </p:txBody>
      </p:sp>
      <p:sp>
        <p:nvSpPr>
          <p:cNvPr id="9" name="文本框 8"/>
          <p:cNvSpPr txBox="1"/>
          <p:nvPr/>
        </p:nvSpPr>
        <p:spPr>
          <a:xfrm>
            <a:off x="3569369" y="78176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a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6157734" y="3220946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c</a:t>
            </a:r>
            <a:endParaRPr lang="zh-CN" altLang="en-US" dirty="0"/>
          </a:p>
        </p:txBody>
      </p:sp>
      <p:sp>
        <p:nvSpPr>
          <p:cNvPr id="14" name="矩形 13"/>
          <p:cNvSpPr/>
          <p:nvPr/>
        </p:nvSpPr>
        <p:spPr>
          <a:xfrm>
            <a:off x="283946" y="187776"/>
            <a:ext cx="11909658" cy="430887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2200" b="1" dirty="0" smtClean="0"/>
              <a:t>Figure S2. </a:t>
            </a:r>
            <a:r>
              <a:rPr lang="en-US" altLang="zh-CN" sz="2200" b="1" dirty="0"/>
              <a:t>CQ </a:t>
            </a:r>
            <a:r>
              <a:rPr lang="en-US" altLang="zh-CN" sz="2200" b="1" dirty="0" smtClean="0"/>
              <a:t> completely  impair </a:t>
            </a:r>
            <a:r>
              <a:rPr lang="en-US" altLang="zh-CN" sz="2200" b="1" dirty="0" err="1" smtClean="0"/>
              <a:t>autophagic</a:t>
            </a:r>
            <a:r>
              <a:rPr lang="en-US" altLang="zh-CN" sz="2200" b="1" dirty="0" smtClean="0"/>
              <a:t> degradation</a:t>
            </a:r>
            <a:endParaRPr lang="zh-CN" altLang="en-US" sz="2200" b="1" dirty="0"/>
          </a:p>
        </p:txBody>
      </p:sp>
      <p:sp>
        <p:nvSpPr>
          <p:cNvPr id="11" name="矩形 10"/>
          <p:cNvSpPr/>
          <p:nvPr/>
        </p:nvSpPr>
        <p:spPr>
          <a:xfrm>
            <a:off x="283946" y="5573118"/>
            <a:ext cx="1148454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APP/PS1 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mice were continuously exposed to 3% sevoflurane or 60% oxygen for 4 h (n=5/group). For 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CQ 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treatment, mice were intraperitoneally pre-injected with 15 mg/kg/day 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CQ 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followed 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by 4 hours of 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sevoflurane or oxygen exposure. (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a) 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Western 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blotting results of p62, 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LC3 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and β-actin in the mouse hippocampus. 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(b, c) 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Quantification of the ratio of p62 or 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LC3II to 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β-actin. 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**</a:t>
            </a:r>
            <a:r>
              <a:rPr lang="en-US" altLang="zh-CN" kern="100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p&lt;0.01, </a:t>
            </a:r>
            <a:r>
              <a:rPr lang="en-US" altLang="zh-CN" kern="100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***p&lt;0.001.</a:t>
            </a:r>
            <a:endParaRPr lang="zh-CN" altLang="en-US" kern="100" dirty="0">
              <a:latin typeface="Times New Roman" panose="02020603050405020304" pitchFamily="18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6217" y="1034685"/>
            <a:ext cx="7020000" cy="21862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696374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2</TotalTime>
  <Words>181</Words>
  <Application>Microsoft Office PowerPoint</Application>
  <PresentationFormat>Custom</PresentationFormat>
  <Paragraphs>1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主题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 继千</dc:creator>
  <cp:lastModifiedBy>arun</cp:lastModifiedBy>
  <cp:revision>15</cp:revision>
  <dcterms:created xsi:type="dcterms:W3CDTF">2018-05-21T08:06:11Z</dcterms:created>
  <dcterms:modified xsi:type="dcterms:W3CDTF">2018-07-02T11:46:22Z</dcterms:modified>
</cp:coreProperties>
</file>